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51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846E56-408A-0E1E-17F8-C37BEE6F92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7C4250A-FD71-0363-D81E-516CF9DD10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7B8A17-E704-CCE7-0900-7817A7471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6E9FE6-DAB8-ADD8-7F90-D237F3927F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61E608-D854-00F0-4792-28B4DA8074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0602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941DDF-D238-AFC8-1B5B-B752B2EFBF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BA2202E-F813-1C6E-9B79-135ED29909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77B9A5F-E9BB-A55A-4484-361212795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A4F577-4764-B546-B984-D0D2B1CB6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B0BAB4-98CB-ED53-866A-A1F49C047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7360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A195687-FCF7-BCF8-DB2A-C46B25C0B1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C13AE9C-2806-1676-C4A1-0BF6830870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B60C01-C462-F4AE-7328-6EFE8BD556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360B7B-A6FF-60C5-A4CF-9ED8C67682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B2E777-B612-A647-AAA5-6574366B2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3034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FD139C-8574-F1AE-B8B1-C0439F9718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DFCEE3-4A10-02EC-B9E9-369B745DBB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8C7909-EE81-4A44-17F2-84814ACB77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A492A4-C555-2621-CEC8-356BDC99E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43878E-DEAD-A01B-862C-FCD1FF9C4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2514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A22F9F-27EF-FE91-60AF-A764FD281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4003524-836D-F0D8-589A-AF8FE44B9D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8AD8FD3-BA4A-9946-8C8B-195B5C34A1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81A8F3E-FA1D-8F5E-44AA-F20582943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674B5B5-5285-49B6-42F1-689F02930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96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669A2D-997C-C660-A3A2-6E6F2DE098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6F3DF74-D250-B39A-E22D-337CD8B426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3CAA32D-97FD-574B-5C2C-1DCEE517E3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6D67238-F0B3-46FD-5ADD-AD10BA483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83C848D-F826-15C8-18E9-9379406B4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18196F8-775C-D491-2B81-0C473F296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4019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4CB19B-34CA-29BE-C2AF-78AAB4B949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65001F2-C219-3302-96CC-137E2F3F1C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78345AE-3A0D-3833-4415-F96076BD76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6A2CCFD-5921-A8DA-B9A4-D992C01993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64DD40A-AD70-55FD-91D1-FADB13866C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92DAEA0-CC58-B2B7-AE3C-14275C81A5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DEFB0D4-947D-6EAD-CC77-4F8C9BD5AB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87EB881-13E4-A030-D0F1-DA02135CA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0296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F931AB-7519-E8C8-8AF9-3E5C34311B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C94B67B-BF42-21CF-397E-F47DD7AAFC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9D35D9B-3CE8-4D53-AF4E-7EBF485E28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F35BFF8-1DF6-8B9D-A544-8DF4B28315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3687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79615E9-D93A-72B0-7C0F-605DC5E3B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DEF47F3-35F9-ECAE-969D-ED4177FBD2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C5A3D5D-4052-6739-7BDC-64E91E9E3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0555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CD91EA-C773-1C67-1946-FE7EEEDBE6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9505190-8B24-26E6-34A6-88DA0B67E2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3172407-1429-E33D-1EE0-11974BC45B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9C406F7-F62E-779C-0303-95FF55B7A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4F14884-912F-E638-84A5-7AE7C6700C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C6CCF79-6484-F0EA-B371-A6FB54A5BF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963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F40760-618C-7324-FA4C-BA30012ED4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33D27AC-D53F-5517-67E0-8604566FB9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E5323FE-F339-F646-63B0-1CCE63BE95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6F183F1-644D-30DF-6F63-7F8DC2C26D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5C00CB3-F541-5727-1C76-4D8712B6F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04F2789-1FDF-9761-E714-483C06789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475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EA59835-282A-F9EF-AD09-11624677EC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7FC818F-A7FB-BA8D-A08A-566168EE02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6EF0944-09E2-B0AE-8BB2-5275053828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C1DA42C-8D50-2D74-BB35-FFAF6FF80C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CCC8109-FF0E-CEB6-4CD5-AF5A1FCF7D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6195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7000C03-103B-95AC-F40F-7CF056E965E3}"/>
              </a:ext>
            </a:extLst>
          </p:cNvPr>
          <p:cNvSpPr txBox="1"/>
          <p:nvPr/>
        </p:nvSpPr>
        <p:spPr>
          <a:xfrm>
            <a:off x="1871807" y="827164"/>
            <a:ext cx="245635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RHISM overall quality</a:t>
            </a:r>
            <a:b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&gt; 10 years of experienc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AB9E7BB-5930-F8C8-C1E1-A2FC87C9EB0C}"/>
              </a:ext>
            </a:extLst>
          </p:cNvPr>
          <p:cNvSpPr txBox="1"/>
          <p:nvPr/>
        </p:nvSpPr>
        <p:spPr>
          <a:xfrm>
            <a:off x="9438309" y="244629"/>
            <a:ext cx="1361633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95% CI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17BC26C-F98E-15A6-2919-ECAA4120406A}"/>
              </a:ext>
            </a:extLst>
          </p:cNvPr>
          <p:cNvSpPr txBox="1"/>
          <p:nvPr/>
        </p:nvSpPr>
        <p:spPr>
          <a:xfrm>
            <a:off x="8036190" y="924864"/>
            <a:ext cx="1361633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57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C7120DC-C15B-94CB-29BF-4686A1305D1D}"/>
              </a:ext>
            </a:extLst>
          </p:cNvPr>
          <p:cNvSpPr txBox="1"/>
          <p:nvPr/>
        </p:nvSpPr>
        <p:spPr>
          <a:xfrm>
            <a:off x="9300526" y="915673"/>
            <a:ext cx="1731420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51, 0.63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9BD983C-7A4D-D3F2-F5E3-11DD1AAAA9F8}"/>
              </a:ext>
            </a:extLst>
          </p:cNvPr>
          <p:cNvSpPr txBox="1"/>
          <p:nvPr/>
        </p:nvSpPr>
        <p:spPr>
          <a:xfrm>
            <a:off x="8036189" y="1794144"/>
            <a:ext cx="1361633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6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2DBA0F7-12C5-CB04-6948-E939810B45D3}"/>
              </a:ext>
            </a:extLst>
          </p:cNvPr>
          <p:cNvSpPr txBox="1"/>
          <p:nvPr/>
        </p:nvSpPr>
        <p:spPr>
          <a:xfrm>
            <a:off x="9300526" y="1792486"/>
            <a:ext cx="1731420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54, 0.65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E8CCF1C-C1B4-99BC-397D-5A0F47764AEE}"/>
              </a:ext>
            </a:extLst>
          </p:cNvPr>
          <p:cNvSpPr txBox="1"/>
          <p:nvPr/>
        </p:nvSpPr>
        <p:spPr>
          <a:xfrm>
            <a:off x="3183562" y="5787660"/>
            <a:ext cx="6272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Cohen’s kappa</a:t>
            </a:r>
            <a:r>
              <a:rPr lang="ja-JP" altLang="en-US" sz="120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(weighted)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63878F1-1172-787C-450F-F69664B14F24}"/>
              </a:ext>
            </a:extLst>
          </p:cNvPr>
          <p:cNvSpPr txBox="1"/>
          <p:nvPr/>
        </p:nvSpPr>
        <p:spPr>
          <a:xfrm>
            <a:off x="7863841" y="241981"/>
            <a:ext cx="176953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hen’s kappa </a:t>
            </a:r>
            <a:endParaRPr lang="ja-JP" altLang="en-US" sz="14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7AE93BB-AE59-BB24-2A66-38A7A09E8710}"/>
              </a:ext>
            </a:extLst>
          </p:cNvPr>
          <p:cNvSpPr txBox="1"/>
          <p:nvPr/>
        </p:nvSpPr>
        <p:spPr>
          <a:xfrm>
            <a:off x="1871807" y="3767213"/>
            <a:ext cx="245635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RHISM overall quality</a:t>
            </a:r>
            <a:b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≤ 10 years of experienc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B9192BE-5434-79DE-1D35-2B8F5120B3E8}"/>
              </a:ext>
            </a:extLst>
          </p:cNvPr>
          <p:cNvSpPr txBox="1"/>
          <p:nvPr/>
        </p:nvSpPr>
        <p:spPr>
          <a:xfrm>
            <a:off x="1871807" y="1697366"/>
            <a:ext cx="245635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ISCERN overall quality</a:t>
            </a:r>
            <a:b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&gt; 10 years of experienc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82F85FF-A442-2BB6-C4DA-BE3C32A91116}"/>
              </a:ext>
            </a:extLst>
          </p:cNvPr>
          <p:cNvSpPr txBox="1"/>
          <p:nvPr/>
        </p:nvSpPr>
        <p:spPr>
          <a:xfrm>
            <a:off x="1871807" y="4536559"/>
            <a:ext cx="245635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ISCERN overall quality</a:t>
            </a:r>
            <a:b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≤ 10 years of experienc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08DC349-ACD7-5DE3-24CC-187422715DBF}"/>
              </a:ext>
            </a:extLst>
          </p:cNvPr>
          <p:cNvSpPr txBox="1"/>
          <p:nvPr/>
        </p:nvSpPr>
        <p:spPr>
          <a:xfrm>
            <a:off x="3183562" y="2906594"/>
            <a:ext cx="6272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Cohen’s kappa</a:t>
            </a:r>
            <a:r>
              <a:rPr lang="ja-JP" altLang="en-US" sz="120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(weighted)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B96299C-C1D1-EB7C-999E-AE0E9F998969}"/>
              </a:ext>
            </a:extLst>
          </p:cNvPr>
          <p:cNvSpPr txBox="1"/>
          <p:nvPr/>
        </p:nvSpPr>
        <p:spPr>
          <a:xfrm>
            <a:off x="9438309" y="3136067"/>
            <a:ext cx="1361633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95% CI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D782AA3-E984-2051-1307-529266608557}"/>
              </a:ext>
            </a:extLst>
          </p:cNvPr>
          <p:cNvSpPr txBox="1"/>
          <p:nvPr/>
        </p:nvSpPr>
        <p:spPr>
          <a:xfrm>
            <a:off x="8036190" y="3816302"/>
            <a:ext cx="1361633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3</a:t>
            </a:r>
            <a:r>
              <a:rPr kumimoji="0" lang="en-US" altLang="ja-JP" sz="1400" kern="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8ED9733-0079-4CCA-76C4-44451555E625}"/>
              </a:ext>
            </a:extLst>
          </p:cNvPr>
          <p:cNvSpPr txBox="1"/>
          <p:nvPr/>
        </p:nvSpPr>
        <p:spPr>
          <a:xfrm>
            <a:off x="9300526" y="3807111"/>
            <a:ext cx="1731420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20, 0.4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3175A62-8A54-0D1A-FDFD-ADE4DF053F84}"/>
              </a:ext>
            </a:extLst>
          </p:cNvPr>
          <p:cNvSpPr txBox="1"/>
          <p:nvPr/>
        </p:nvSpPr>
        <p:spPr>
          <a:xfrm>
            <a:off x="8036189" y="4685582"/>
            <a:ext cx="1361633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21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2C1B66D-CFE4-919E-B504-125B8D34AE70}"/>
              </a:ext>
            </a:extLst>
          </p:cNvPr>
          <p:cNvSpPr txBox="1"/>
          <p:nvPr/>
        </p:nvSpPr>
        <p:spPr>
          <a:xfrm>
            <a:off x="9300526" y="4683924"/>
            <a:ext cx="1731420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</a:t>
            </a:r>
            <a:r>
              <a:rPr kumimoji="0" lang="en-US" altLang="ja-JP" sz="1400" kern="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12,</a:t>
            </a: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 0.29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A4E22C1-22B3-C655-5F0D-32135A975410}"/>
              </a:ext>
            </a:extLst>
          </p:cNvPr>
          <p:cNvSpPr txBox="1"/>
          <p:nvPr/>
        </p:nvSpPr>
        <p:spPr>
          <a:xfrm>
            <a:off x="7863841" y="3133419"/>
            <a:ext cx="176953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hen’s kappa </a:t>
            </a:r>
            <a:endParaRPr lang="ja-JP" altLang="en-US" sz="1400" dirty="0"/>
          </a:p>
        </p:txBody>
      </p:sp>
      <p:pic>
        <p:nvPicPr>
          <p:cNvPr id="32" name="図 31">
            <a:extLst>
              <a:ext uri="{FF2B5EF4-FFF2-40B4-BE49-F238E27FC236}">
                <a16:creationId xmlns:a16="http://schemas.microsoft.com/office/drawing/2014/main" id="{10048609-FED6-89C5-9B0D-BFC93766349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162" t="8016" b="52541"/>
          <a:stretch/>
        </p:blipFill>
        <p:spPr>
          <a:xfrm>
            <a:off x="4328160" y="517836"/>
            <a:ext cx="3578778" cy="2394000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ED1FD715-A7DF-2231-95BC-E9B37B1C0F0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162" t="57911" b="2224"/>
          <a:stretch/>
        </p:blipFill>
        <p:spPr>
          <a:xfrm>
            <a:off x="4321705" y="3442050"/>
            <a:ext cx="3540972" cy="239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3297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61</TotalTime>
  <Words>72</Words>
  <Application>Microsoft Office PowerPoint</Application>
  <PresentationFormat>ワイド画面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日馬 弘貴</dc:creator>
  <cp:lastModifiedBy>弘貴 日馬</cp:lastModifiedBy>
  <cp:revision>20</cp:revision>
  <dcterms:created xsi:type="dcterms:W3CDTF">2024-06-13T10:20:34Z</dcterms:created>
  <dcterms:modified xsi:type="dcterms:W3CDTF">2024-09-19T08:00:00Z</dcterms:modified>
</cp:coreProperties>
</file>